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93" r:id="rId2"/>
  </p:sldIdLst>
  <p:sldSz cx="12192000" cy="6858000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FF"/>
    <a:srgbClr val="FF99CC"/>
    <a:srgbClr val="9CF8A0"/>
    <a:srgbClr val="FFFFCC"/>
    <a:srgbClr val="2BF343"/>
    <a:srgbClr val="E7FF01"/>
    <a:srgbClr val="99FFCC"/>
    <a:srgbClr val="00FF00"/>
    <a:srgbClr val="FFFF00"/>
    <a:srgbClr val="00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405" autoAdjust="0"/>
    <p:restoredTop sz="89196" autoAdjust="0"/>
  </p:normalViewPr>
  <p:slideViewPr>
    <p:cSldViewPr snapToGrid="0">
      <p:cViewPr varScale="1">
        <p:scale>
          <a:sx n="131" d="100"/>
          <a:sy n="131" d="100"/>
        </p:scale>
        <p:origin x="138" y="11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390" tIns="47695" rIns="95390" bIns="47695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390" tIns="47695" rIns="95390" bIns="47695" rtlCol="0"/>
          <a:lstStyle>
            <a:lvl1pPr algn="r">
              <a:defRPr sz="1300"/>
            </a:lvl1pPr>
          </a:lstStyle>
          <a:p>
            <a:fld id="{4110BF96-1A77-4303-8468-6D4F197C9A1B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1277938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390" tIns="47695" rIns="95390" bIns="47695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9931" y="4925408"/>
            <a:ext cx="5679440" cy="4029879"/>
          </a:xfrm>
          <a:prstGeom prst="rect">
            <a:avLst/>
          </a:prstGeom>
        </p:spPr>
        <p:txBody>
          <a:bodyPr vert="horz" lIns="95390" tIns="47695" rIns="95390" bIns="47695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5390" tIns="47695" rIns="95390" bIns="47695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5390" tIns="47695" rIns="95390" bIns="47695" rtlCol="0" anchor="b"/>
          <a:lstStyle>
            <a:lvl1pPr algn="r">
              <a:defRPr sz="1300"/>
            </a:lvl1pPr>
          </a:lstStyle>
          <a:p>
            <a:fld id="{76A9539B-17B8-4317-A85C-D10932E739B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771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>Sup Table 1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A9539B-17B8-4317-A85C-D10932E739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22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334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84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187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810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20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806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439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79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997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003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92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AF230-4ACB-47E6-B153-50E1F8E5A04D}" type="datetimeFigureOut">
              <a:rPr lang="en-US" smtClean="0"/>
              <a:t>7/2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1D549-E728-4A9E-BD0B-DD5C2C805B3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918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4808686"/>
            <a:ext cx="12192000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tabLst>
                <a:tab pos="1198880" algn="l"/>
              </a:tabLst>
            </a:pPr>
            <a:r>
              <a:rPr lang="en-US" sz="1200" b="1" dirty="0"/>
              <a:t>Supplemental</a:t>
            </a:r>
            <a:r>
              <a:rPr lang="en-US" sz="1200" dirty="0"/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: Oligonucleotides used to generate constructs (GFP and CFP fusions) to validate subcellular and </a:t>
            </a:r>
            <a:r>
              <a:rPr lang="en-US" sz="1200" b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plastidial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ocalization of TSP9, SFR2, UP1, eIF5A and VTE1 proteins </a:t>
            </a:r>
            <a:r>
              <a:rPr lang="en-US" sz="1200" dirty="0"/>
              <a:t>(see Fig. </a:t>
            </a:r>
            <a:r>
              <a:rPr lang="en-US" sz="1200" smtClean="0"/>
              <a:t>10).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2381715"/>
              </p:ext>
            </p:extLst>
          </p:nvPr>
        </p:nvGraphicFramePr>
        <p:xfrm>
          <a:off x="2790190" y="1388680"/>
          <a:ext cx="6083300" cy="294938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5781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0">
                <a:tc gridSpan="5">
                  <a:txBody>
                    <a:bodyPr/>
                    <a:lstStyle/>
                    <a:p>
                      <a:pPr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effectLst/>
                        </a:rPr>
                        <a:t>A. Oligonucleotides primers used for Gateway cloning strategy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Number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Accession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Nickname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Oligonucleotides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Sequence 5'-3'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000" kern="1200">
                          <a:effectLst/>
                        </a:rPr>
                        <a:t>AT3G4707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TSP9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TSP9 TOPO fw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ccacATGGTTTCTTCGCTTCTTAT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TSP9 TOPO rev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TTTCTTGAAGAGGCTTCCTAA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000" kern="1200">
                          <a:effectLst/>
                        </a:rPr>
                        <a:t>AT3G0651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SFR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SFR2 TOPO fw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ccacATGGAATTATTCGCATTGTT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SFR2 TOPO rev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GTCAAAGGGTGAGGCTA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 </a:t>
                      </a:r>
                      <a:endParaRPr lang="fr-FR" sz="1100">
                        <a:effectLst/>
                      </a:endParaRPr>
                    </a:p>
                    <a:p>
                      <a:pPr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effectLst/>
                        </a:rPr>
                        <a:t>B. Oligonucleotides primers used for classical cloning strategy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Accession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Nickname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Oligonucleotides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Sequence 5'-3'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000" kern="1200">
                          <a:effectLst/>
                        </a:rPr>
                        <a:t>AT1G1132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UP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UP1 SalI fw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GTCGACATGGACCCAATTGCTTCG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UP1 NcoI rev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CCATGGACAGCGACCAGTGAGACTTTAG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4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000" kern="1200">
                          <a:effectLst/>
                        </a:rPr>
                        <a:t>AT1G2663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eIF-5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eIF5A SalI fw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GTCGACATGTCTGACGACGAGCACC  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eIF5A BspHI rev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TCATGAACTTGCCACCACCAACTTCC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81280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1000" kern="1200">
                          <a:effectLst/>
                        </a:rPr>
                        <a:t>AT4G3277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VTE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VTE1 SalI fwd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cap="all">
                          <a:effectLst/>
                        </a:rPr>
                        <a:t>tctgtcgacatggagatacggagcttg</a:t>
                      </a:r>
                      <a:r>
                        <a:rPr lang="en-US" sz="800" cap="all">
                          <a:effectLst/>
                          <a:highlight>
                            <a:srgbClr val="00FF00"/>
                          </a:highlight>
                        </a:rPr>
                        <a:t> 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8128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fr-FR" sz="800" kern="1200">
                          <a:effectLst/>
                        </a:rPr>
                        <a:t>VTE1 NcoI rev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cap="all">
                          <a:effectLst/>
                        </a:rPr>
                        <a:t>atcccatggacagacccggtggcttg</a:t>
                      </a:r>
                      <a:r>
                        <a:rPr lang="en-US" sz="800" cap="all">
                          <a:effectLst/>
                          <a:highlight>
                            <a:srgbClr val="00FF00"/>
                          </a:highlight>
                        </a:rPr>
                        <a:t> 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fr-FR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6695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01</TotalTime>
  <Words>123</Words>
  <Application>Microsoft Office PowerPoint</Application>
  <PresentationFormat>Grand écran</PresentationFormat>
  <Paragraphs>5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E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OUCHNAK Imen 247267</dc:creator>
  <cp:lastModifiedBy>ROLLAND Norbert 154855</cp:lastModifiedBy>
  <cp:revision>744</cp:revision>
  <cp:lastPrinted>2018-02-27T18:17:38Z</cp:lastPrinted>
  <dcterms:created xsi:type="dcterms:W3CDTF">2017-06-14T16:26:33Z</dcterms:created>
  <dcterms:modified xsi:type="dcterms:W3CDTF">2018-07-25T12:47:56Z</dcterms:modified>
</cp:coreProperties>
</file>